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6858000" cy="9144000" type="screen4x3"/>
  <p:notesSz cx="6669088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B" initials="B" lastIdx="1" clrIdx="0"/>
  <p:cmAuthor id="1" name="Tuchscherr de Hauschopp, Lorena" initials="TdHL" lastIdx="1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-2646" y="-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382667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577104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21432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313757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538031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22477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86695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273994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190742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739532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885502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077226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14772" y="827584"/>
            <a:ext cx="147508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>
                <a:latin typeface="Arial" pitchFamily="34" charset="0"/>
                <a:cs typeface="Arial" pitchFamily="34" charset="0"/>
              </a:rPr>
              <a:t>CFU/ml after  0 </a:t>
            </a:r>
            <a:r>
              <a:rPr lang="de-DE" sz="1100" dirty="0" err="1" smtClean="0">
                <a:latin typeface="Arial" pitchFamily="34" charset="0"/>
                <a:cs typeface="Arial" pitchFamily="34" charset="0"/>
              </a:rPr>
              <a:t>days</a:t>
            </a:r>
            <a:endParaRPr 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243275" y="1180982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S1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3579225" y="1182050"/>
            <a:ext cx="7377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H1000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252594" y="179398"/>
            <a:ext cx="62727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itchFamily="34" charset="0"/>
                <a:cs typeface="Arial" pitchFamily="34" charset="0"/>
              </a:rPr>
              <a:t>Supporting Information Fig. 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S5: 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Host cell invasion after 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infection of osteoblasts with LS1 and SH1000 and their mutant derivates </a:t>
            </a:r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2549" y="1689200"/>
            <a:ext cx="2614613" cy="26931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17031" y="1689200"/>
            <a:ext cx="2614613" cy="233600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747375681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</Words>
  <Application>Microsoft Office PowerPoint</Application>
  <PresentationFormat>Bildschirmpräsentation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niversitätsklinikum Jen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uchscherr de Hauschopp, Lorena</dc:creator>
  <cp:lastModifiedBy>Tuchscherr de Hauschopp, Lorena</cp:lastModifiedBy>
  <cp:revision>73</cp:revision>
  <cp:lastPrinted>2015-02-05T15:03:15Z</cp:lastPrinted>
  <dcterms:created xsi:type="dcterms:W3CDTF">2014-11-04T10:41:58Z</dcterms:created>
  <dcterms:modified xsi:type="dcterms:W3CDTF">2015-04-13T07:30:39Z</dcterms:modified>
</cp:coreProperties>
</file>